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3072" y="-6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oyamakentarou:Desktop:&#20024;&#21892;%209.27.26:151109%20GR-SU%20growth%20strain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oyamakentarou:Desktop:&#20024;&#21892;%209.27.26:151109%20GRA%20growth%20strain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oyamakentarou:Desktop:&#20024;&#21892;%209.27.26:151109%20%20&#25239;&#33740;assay&#12288;MS23513%20Growt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oyamakentarou:Desktop:&#20024;&#21892;%209.27.26:151109%20%20&#25239;&#33740;assay&#12288;MS23513%20Growt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250494155867"/>
          <c:y val="0.0355104132589252"/>
          <c:w val="0.817108977355116"/>
          <c:h val="0.835908337597379"/>
        </c:manualLayout>
      </c:layout>
      <c:lineChart>
        <c:grouping val="standard"/>
        <c:varyColors val="0"/>
        <c:ser>
          <c:idx val="0"/>
          <c:order val="0"/>
          <c:tx>
            <c:strRef>
              <c:f>Sheet1!$B$13</c:f>
              <c:strCache>
                <c:ptCount val="1"/>
                <c:pt idx="0">
                  <c:v>con</c:v>
                </c:pt>
              </c:strCache>
            </c:strRef>
          </c:tx>
          <c:spPr>
            <a:ln w="6350" cmpd="sng">
              <a:solidFill>
                <a:schemeClr val="tx1"/>
              </a:solidFill>
            </a:ln>
            <a:effectLst/>
          </c:spPr>
          <c:marker>
            <c:symbol val="squar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2:$F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18415464455544</c:v>
                  </c:pt>
                  <c:pt idx="4">
                    <c:v>0.0167796172648709</c:v>
                  </c:pt>
                  <c:pt idx="5">
                    <c:v>0.0490374006923967</c:v>
                  </c:pt>
                  <c:pt idx="6">
                    <c:v>0.0128322510366135</c:v>
                  </c:pt>
                  <c:pt idx="7">
                    <c:v>0.0663341708489842</c:v>
                  </c:pt>
                  <c:pt idx="8">
                    <c:v>0.0392173431022551</c:v>
                  </c:pt>
                </c:numCache>
              </c:numRef>
            </c:plus>
            <c:minus>
              <c:numRef>
                <c:f>Sheet1!$F$2:$F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18415464455544</c:v>
                  </c:pt>
                  <c:pt idx="4">
                    <c:v>0.0167796172648709</c:v>
                  </c:pt>
                  <c:pt idx="5">
                    <c:v>0.0490374006923967</c:v>
                  </c:pt>
                  <c:pt idx="6">
                    <c:v>0.0128322510366135</c:v>
                  </c:pt>
                  <c:pt idx="7">
                    <c:v>0.0663341708489842</c:v>
                  </c:pt>
                  <c:pt idx="8">
                    <c:v>0.0392173431022551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B$14:$B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97666666666667</c:v>
                </c:pt>
                <c:pt idx="4">
                  <c:v>0.886666666666667</c:v>
                </c:pt>
                <c:pt idx="5">
                  <c:v>1.67</c:v>
                </c:pt>
                <c:pt idx="6">
                  <c:v>1.675</c:v>
                </c:pt>
                <c:pt idx="7">
                  <c:v>1.776666666666667</c:v>
                </c:pt>
                <c:pt idx="8">
                  <c:v>1.8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Sheet1!$D$13</c:f>
              <c:strCache>
                <c:ptCount val="1"/>
                <c:pt idx="0">
                  <c:v>1/16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H$2:$AH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229830855679176</c:v>
                  </c:pt>
                  <c:pt idx="4">
                    <c:v>0.0286744175568088</c:v>
                  </c:pt>
                  <c:pt idx="5">
                    <c:v>0.0318747549010184</c:v>
                  </c:pt>
                  <c:pt idx="6">
                    <c:v>0.068585712797929</c:v>
                  </c:pt>
                  <c:pt idx="7">
                    <c:v>0.0653214274866134</c:v>
                  </c:pt>
                  <c:pt idx="8">
                    <c:v>0.0682169741014327</c:v>
                  </c:pt>
                </c:numCache>
              </c:numRef>
            </c:plus>
            <c:minus>
              <c:numRef>
                <c:f>Sheet1!$AH$2:$AH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229830855679176</c:v>
                  </c:pt>
                  <c:pt idx="4">
                    <c:v>0.0286744175568088</c:v>
                  </c:pt>
                  <c:pt idx="5">
                    <c:v>0.0318747549010184</c:v>
                  </c:pt>
                  <c:pt idx="6">
                    <c:v>0.068585712797929</c:v>
                  </c:pt>
                  <c:pt idx="7">
                    <c:v>0.0653214274866134</c:v>
                  </c:pt>
                  <c:pt idx="8">
                    <c:v>0.0682169741014327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D$14:$D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59333333333333</c:v>
                </c:pt>
                <c:pt idx="4">
                  <c:v>0.849333333333333</c:v>
                </c:pt>
                <c:pt idx="5">
                  <c:v>0.983</c:v>
                </c:pt>
                <c:pt idx="6">
                  <c:v>1.173</c:v>
                </c:pt>
                <c:pt idx="7">
                  <c:v>1.416666666666667</c:v>
                </c:pt>
                <c:pt idx="8">
                  <c:v>1.573333333333333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Sheet1!$E$13</c:f>
              <c:strCache>
                <c:ptCount val="1"/>
                <c:pt idx="0">
                  <c:v>1/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A$2:$AA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40554457615387</c:v>
                  </c:pt>
                  <c:pt idx="4">
                    <c:v>0.012684198393627</c:v>
                  </c:pt>
                  <c:pt idx="5">
                    <c:v>0.0605383257853146</c:v>
                  </c:pt>
                  <c:pt idx="6">
                    <c:v>0.00668331255192119</c:v>
                  </c:pt>
                  <c:pt idx="7">
                    <c:v>0.0037712361663282</c:v>
                  </c:pt>
                  <c:pt idx="8">
                    <c:v>0.0064807406984079</c:v>
                  </c:pt>
                </c:numCache>
              </c:numRef>
            </c:plus>
            <c:minus>
              <c:numRef>
                <c:f>Sheet1!$AA$2:$AA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40554457615387</c:v>
                  </c:pt>
                  <c:pt idx="4">
                    <c:v>0.012684198393627</c:v>
                  </c:pt>
                  <c:pt idx="5">
                    <c:v>0.0605383257853146</c:v>
                  </c:pt>
                  <c:pt idx="6">
                    <c:v>0.00668331255192119</c:v>
                  </c:pt>
                  <c:pt idx="7">
                    <c:v>0.0037712361663282</c:v>
                  </c:pt>
                  <c:pt idx="8">
                    <c:v>0.0064807406984079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E$14:$E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32666666666667</c:v>
                </c:pt>
                <c:pt idx="4">
                  <c:v>0.681666666666667</c:v>
                </c:pt>
                <c:pt idx="5">
                  <c:v>0.866666666666667</c:v>
                </c:pt>
                <c:pt idx="6">
                  <c:v>0.985</c:v>
                </c:pt>
                <c:pt idx="7">
                  <c:v>1.038333333333333</c:v>
                </c:pt>
                <c:pt idx="8">
                  <c:v>1.055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Sheet1!$F$13</c:f>
              <c:strCache>
                <c:ptCount val="1"/>
                <c:pt idx="0">
                  <c:v>1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star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T$2:$T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7461067804945</c:v>
                  </c:pt>
                  <c:pt idx="4">
                    <c:v>0.01506283137026</c:v>
                  </c:pt>
                  <c:pt idx="5">
                    <c:v>0.0111455023315336</c:v>
                  </c:pt>
                  <c:pt idx="6">
                    <c:v>0.0238467328300266</c:v>
                  </c:pt>
                  <c:pt idx="7">
                    <c:v>0.0118977121983831</c:v>
                  </c:pt>
                  <c:pt idx="8">
                    <c:v>0.0448131925020101</c:v>
                  </c:pt>
                </c:numCache>
              </c:numRef>
            </c:plus>
            <c:minus>
              <c:numRef>
                <c:f>Sheet1!$T$2:$T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7461067804945</c:v>
                  </c:pt>
                  <c:pt idx="4">
                    <c:v>0.01506283137026</c:v>
                  </c:pt>
                  <c:pt idx="5">
                    <c:v>0.0111455023315336</c:v>
                  </c:pt>
                  <c:pt idx="6">
                    <c:v>0.0238467328300266</c:v>
                  </c:pt>
                  <c:pt idx="7">
                    <c:v>0.0118977121983831</c:v>
                  </c:pt>
                  <c:pt idx="8">
                    <c:v>0.0448131925020101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F$14:$F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285333333333333</c:v>
                </c:pt>
                <c:pt idx="4">
                  <c:v>0.335333333333333</c:v>
                </c:pt>
                <c:pt idx="5">
                  <c:v>0.373666666666667</c:v>
                </c:pt>
                <c:pt idx="6">
                  <c:v>0.395</c:v>
                </c:pt>
                <c:pt idx="7">
                  <c:v>0.414333333333333</c:v>
                </c:pt>
                <c:pt idx="8">
                  <c:v>0.444666666666667</c:v>
                </c:pt>
              </c:numCache>
            </c:numRef>
          </c:val>
          <c:smooth val="0"/>
        </c:ser>
        <c:ser>
          <c:idx val="5"/>
          <c:order val="4"/>
          <c:tx>
            <c:strRef>
              <c:f>Sheet1!$G$13</c:f>
              <c:strCache>
                <c:ptCount val="1"/>
                <c:pt idx="0">
                  <c:v>2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</c:spPr>
          <c:marker>
            <c:symbol val="plus"/>
            <c:size val="9"/>
            <c:spPr>
              <a:gradFill flip="none" rotWithShape="1">
                <a:gsLst>
                  <a:gs pos="0">
                    <a:schemeClr val="tx1"/>
                  </a:gs>
                  <a:gs pos="100000">
                    <a:srgbClr val="FFFFFF"/>
                  </a:gs>
                </a:gsLst>
                <a:lin ang="0" scaled="1"/>
                <a:tileRect/>
              </a:gra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2:$M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321351313466534</c:v>
                  </c:pt>
                  <c:pt idx="4">
                    <c:v>0.0518609251320833</c:v>
                  </c:pt>
                  <c:pt idx="5">
                    <c:v>0.012657891697365</c:v>
                  </c:pt>
                  <c:pt idx="6">
                    <c:v>0.0155134350376268</c:v>
                  </c:pt>
                  <c:pt idx="7">
                    <c:v>0.0694166166466407</c:v>
                  </c:pt>
                  <c:pt idx="8">
                    <c:v>0.0692162472898442</c:v>
                  </c:pt>
                </c:numCache>
              </c:numRef>
            </c:plus>
            <c:minus>
              <c:numRef>
                <c:f>Sheet1!$M$2:$M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321351313466534</c:v>
                  </c:pt>
                  <c:pt idx="4">
                    <c:v>0.0518609251320833</c:v>
                  </c:pt>
                  <c:pt idx="5">
                    <c:v>0.012657891697365</c:v>
                  </c:pt>
                  <c:pt idx="6">
                    <c:v>0.0155134350376268</c:v>
                  </c:pt>
                  <c:pt idx="7">
                    <c:v>0.0694166166466407</c:v>
                  </c:pt>
                  <c:pt idx="8">
                    <c:v>0.0692162472898442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G$14:$G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304</c:v>
                </c:pt>
                <c:pt idx="4">
                  <c:v>0.306666666666667</c:v>
                </c:pt>
                <c:pt idx="5">
                  <c:v>0.350333333333333</c:v>
                </c:pt>
                <c:pt idx="6">
                  <c:v>0.34</c:v>
                </c:pt>
                <c:pt idx="7">
                  <c:v>0.344</c:v>
                </c:pt>
                <c:pt idx="8">
                  <c:v>0.3786666666666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6016392"/>
        <c:axId val="-1330345400"/>
      </c:lineChart>
      <c:catAx>
        <c:axId val="-2026016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1330345400"/>
        <c:crossesAt val="0.0"/>
        <c:auto val="1"/>
        <c:lblAlgn val="ctr"/>
        <c:lblOffset val="100"/>
        <c:tickLblSkip val="2"/>
        <c:tickMarkSkip val="2"/>
        <c:noMultiLvlLbl val="0"/>
      </c:catAx>
      <c:valAx>
        <c:axId val="-1330345400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026016392"/>
        <c:crosses val="autoZero"/>
        <c:crossBetween val="midCat"/>
        <c:majorUnit val="0.5"/>
      </c:valAx>
      <c:spPr>
        <a:ln w="6350" cmpd="sng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3</c:f>
              <c:strCache>
                <c:ptCount val="1"/>
                <c:pt idx="0">
                  <c:v>con</c:v>
                </c:pt>
              </c:strCache>
            </c:strRef>
          </c:tx>
          <c:spPr>
            <a:ln w="6350" cmpd="sng">
              <a:solidFill>
                <a:schemeClr val="tx1"/>
              </a:solidFill>
            </a:ln>
            <a:effectLst/>
          </c:spPr>
          <c:marker>
            <c:symbol val="squar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2:$F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18415464455544</c:v>
                  </c:pt>
                  <c:pt idx="4">
                    <c:v>0.0167796172648709</c:v>
                  </c:pt>
                  <c:pt idx="5">
                    <c:v>0.0490374006923967</c:v>
                  </c:pt>
                  <c:pt idx="6">
                    <c:v>0.0128322510366135</c:v>
                  </c:pt>
                  <c:pt idx="7">
                    <c:v>0.0663341708489842</c:v>
                  </c:pt>
                  <c:pt idx="8">
                    <c:v>0.0392173431022551</c:v>
                  </c:pt>
                </c:numCache>
              </c:numRef>
            </c:plus>
            <c:minus>
              <c:numRef>
                <c:f>Sheet1!$F$2:$F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18415464455544</c:v>
                  </c:pt>
                  <c:pt idx="4">
                    <c:v>0.0167796172648709</c:v>
                  </c:pt>
                  <c:pt idx="5">
                    <c:v>0.0490374006923967</c:v>
                  </c:pt>
                  <c:pt idx="6">
                    <c:v>0.0128322510366135</c:v>
                  </c:pt>
                  <c:pt idx="7">
                    <c:v>0.0663341708489842</c:v>
                  </c:pt>
                  <c:pt idx="8">
                    <c:v>0.0392173431022551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B$14:$B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97666666666667</c:v>
                </c:pt>
                <c:pt idx="4">
                  <c:v>0.886666666666667</c:v>
                </c:pt>
                <c:pt idx="5">
                  <c:v>1.67</c:v>
                </c:pt>
                <c:pt idx="6">
                  <c:v>1.675</c:v>
                </c:pt>
                <c:pt idx="7">
                  <c:v>1.776666666666667</c:v>
                </c:pt>
                <c:pt idx="8">
                  <c:v>1.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13</c:f>
              <c:strCache>
                <c:ptCount val="1"/>
                <c:pt idx="0">
                  <c:v>1/6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O$2:$AO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4613540144522</c:v>
                  </c:pt>
                  <c:pt idx="4">
                    <c:v>0.0333566585057116</c:v>
                  </c:pt>
                  <c:pt idx="5">
                    <c:v>0.0975943987463761</c:v>
                  </c:pt>
                  <c:pt idx="6">
                    <c:v>0.0469775360027417</c:v>
                  </c:pt>
                  <c:pt idx="7">
                    <c:v>0.130614785618712</c:v>
                  </c:pt>
                  <c:pt idx="8">
                    <c:v>0.0250377492776185</c:v>
                  </c:pt>
                </c:numCache>
              </c:numRef>
            </c:plus>
            <c:minus>
              <c:numRef>
                <c:f>Sheet1!$AO$2:$AO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4613540144522</c:v>
                  </c:pt>
                  <c:pt idx="4">
                    <c:v>0.0333566585057116</c:v>
                  </c:pt>
                  <c:pt idx="5">
                    <c:v>0.0975943987463761</c:v>
                  </c:pt>
                  <c:pt idx="6">
                    <c:v>0.0469775360027417</c:v>
                  </c:pt>
                  <c:pt idx="7">
                    <c:v>0.130614785618712</c:v>
                  </c:pt>
                  <c:pt idx="8">
                    <c:v>0.0250377492776185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C$14:$C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90666666666667</c:v>
                </c:pt>
                <c:pt idx="4">
                  <c:v>0.908</c:v>
                </c:pt>
                <c:pt idx="5">
                  <c:v>1.57</c:v>
                </c:pt>
                <c:pt idx="6">
                  <c:v>1.676666666666666</c:v>
                </c:pt>
                <c:pt idx="7">
                  <c:v>1.676666666666667</c:v>
                </c:pt>
                <c:pt idx="8">
                  <c:v>1.75333333333333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D$13</c:f>
              <c:strCache>
                <c:ptCount val="1"/>
                <c:pt idx="0">
                  <c:v>1/16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triang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H$2:$AH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335890193697616</c:v>
                  </c:pt>
                  <c:pt idx="4">
                    <c:v>0.0459879211194514</c:v>
                  </c:pt>
                  <c:pt idx="5">
                    <c:v>0.0392258418222818</c:v>
                  </c:pt>
                  <c:pt idx="6">
                    <c:v>0.0933702308018996</c:v>
                  </c:pt>
                  <c:pt idx="7">
                    <c:v>0.0468828326789242</c:v>
                  </c:pt>
                  <c:pt idx="8">
                    <c:v>0.0699539531088526</c:v>
                  </c:pt>
                </c:numCache>
              </c:numRef>
            </c:plus>
            <c:minus>
              <c:numRef>
                <c:f>Sheet1!$AH$2:$AH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335890193697616</c:v>
                  </c:pt>
                  <c:pt idx="4">
                    <c:v>0.0459879211194514</c:v>
                  </c:pt>
                  <c:pt idx="5">
                    <c:v>0.0392258418222818</c:v>
                  </c:pt>
                  <c:pt idx="6">
                    <c:v>0.0933702308018996</c:v>
                  </c:pt>
                  <c:pt idx="7">
                    <c:v>0.0468828326789242</c:v>
                  </c:pt>
                  <c:pt idx="8">
                    <c:v>0.0699539531088526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D$14:$D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50666666666667</c:v>
                </c:pt>
                <c:pt idx="4">
                  <c:v>0.873333333333333</c:v>
                </c:pt>
                <c:pt idx="5">
                  <c:v>1.002</c:v>
                </c:pt>
                <c:pt idx="6">
                  <c:v>1.21</c:v>
                </c:pt>
                <c:pt idx="7">
                  <c:v>1.43</c:v>
                </c:pt>
                <c:pt idx="8">
                  <c:v>1.52666666666666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E$13</c:f>
              <c:strCache>
                <c:ptCount val="1"/>
                <c:pt idx="0">
                  <c:v>1/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A$2:$AA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6739839372653</c:v>
                  </c:pt>
                  <c:pt idx="4">
                    <c:v>0.0170489491367259</c:v>
                  </c:pt>
                  <c:pt idx="5">
                    <c:v>0.0255734237050889</c:v>
                  </c:pt>
                  <c:pt idx="6">
                    <c:v>0.00928559218478942</c:v>
                  </c:pt>
                  <c:pt idx="7">
                    <c:v>0.0105303793326208</c:v>
                  </c:pt>
                  <c:pt idx="8">
                    <c:v>0.00616441400296893</c:v>
                  </c:pt>
                </c:numCache>
              </c:numRef>
            </c:plus>
            <c:minus>
              <c:numRef>
                <c:f>Sheet1!$AA$2:$AA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16739839372653</c:v>
                  </c:pt>
                  <c:pt idx="4">
                    <c:v>0.0170489491367259</c:v>
                  </c:pt>
                  <c:pt idx="5">
                    <c:v>0.0255734237050889</c:v>
                  </c:pt>
                  <c:pt idx="6">
                    <c:v>0.00928559218478942</c:v>
                  </c:pt>
                  <c:pt idx="7">
                    <c:v>0.0105303793326208</c:v>
                  </c:pt>
                  <c:pt idx="8">
                    <c:v>0.00616441400296893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E$14:$E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570666666666667</c:v>
                </c:pt>
                <c:pt idx="4">
                  <c:v>0.675</c:v>
                </c:pt>
                <c:pt idx="5">
                  <c:v>0.837</c:v>
                </c:pt>
                <c:pt idx="6">
                  <c:v>1.098333333333333</c:v>
                </c:pt>
                <c:pt idx="7">
                  <c:v>1.165666666666667</c:v>
                </c:pt>
                <c:pt idx="8">
                  <c:v>1.178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F$13</c:f>
              <c:strCache>
                <c:ptCount val="1"/>
                <c:pt idx="0">
                  <c:v>1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star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T$2:$T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0837987005998436</c:v>
                  </c:pt>
                  <c:pt idx="4">
                    <c:v>0.0408357142163028</c:v>
                  </c:pt>
                  <c:pt idx="5">
                    <c:v>0.0444397219713274</c:v>
                  </c:pt>
                  <c:pt idx="6">
                    <c:v>0.0522642856600523</c:v>
                  </c:pt>
                  <c:pt idx="7">
                    <c:v>0.0243629956194955</c:v>
                  </c:pt>
                  <c:pt idx="8">
                    <c:v>0.0556496980125578</c:v>
                  </c:pt>
                </c:numCache>
              </c:numRef>
            </c:plus>
            <c:minus>
              <c:numRef>
                <c:f>Sheet1!$T$2:$T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0837987005998436</c:v>
                  </c:pt>
                  <c:pt idx="4">
                    <c:v>0.0408357142163028</c:v>
                  </c:pt>
                  <c:pt idx="5">
                    <c:v>0.0444397219713274</c:v>
                  </c:pt>
                  <c:pt idx="6">
                    <c:v>0.0522642856600523</c:v>
                  </c:pt>
                  <c:pt idx="7">
                    <c:v>0.0243629956194955</c:v>
                  </c:pt>
                  <c:pt idx="8">
                    <c:v>0.0556496980125578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F$14:$F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294666666666667</c:v>
                </c:pt>
                <c:pt idx="4">
                  <c:v>0.321666666666667</c:v>
                </c:pt>
                <c:pt idx="5">
                  <c:v>0.415666666666667</c:v>
                </c:pt>
                <c:pt idx="6">
                  <c:v>0.449666666666667</c:v>
                </c:pt>
                <c:pt idx="7">
                  <c:v>0.480333333333333</c:v>
                </c:pt>
                <c:pt idx="8">
                  <c:v>0.500666666666667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heet1!$G$13</c:f>
              <c:strCache>
                <c:ptCount val="1"/>
                <c:pt idx="0">
                  <c:v>2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</c:spPr>
          <c:marker>
            <c:symbol val="plus"/>
            <c:size val="9"/>
            <c:spPr>
              <a:gradFill flip="none" rotWithShape="1">
                <a:gsLst>
                  <a:gs pos="0">
                    <a:schemeClr val="tx1"/>
                  </a:gs>
                  <a:gs pos="100000">
                    <a:srgbClr val="FFFFFF"/>
                  </a:gs>
                </a:gsLst>
                <a:lin ang="0" scaled="1"/>
                <a:tileRect/>
              </a:gra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2:$M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0793025150224686</c:v>
                  </c:pt>
                  <c:pt idx="4">
                    <c:v>0.0394658783705056</c:v>
                  </c:pt>
                  <c:pt idx="5">
                    <c:v>0.0516978400580398</c:v>
                  </c:pt>
                  <c:pt idx="6">
                    <c:v>0.0427629122799965</c:v>
                  </c:pt>
                  <c:pt idx="7">
                    <c:v>0.077461101349143</c:v>
                  </c:pt>
                  <c:pt idx="8">
                    <c:v>0.0187794213613377</c:v>
                  </c:pt>
                </c:numCache>
              </c:numRef>
            </c:plus>
            <c:minus>
              <c:numRef>
                <c:f>Sheet1!$M$2:$M$10</c:f>
                <c:numCache>
                  <c:formatCode>General</c:formatCode>
                  <c:ptCount val="9"/>
                  <c:pt idx="0">
                    <c:v>0.0</c:v>
                  </c:pt>
                  <c:pt idx="1">
                    <c:v>0.00679869268479038</c:v>
                  </c:pt>
                  <c:pt idx="2">
                    <c:v>0.00492160768674445</c:v>
                  </c:pt>
                  <c:pt idx="3">
                    <c:v>0.00793025150224686</c:v>
                  </c:pt>
                  <c:pt idx="4">
                    <c:v>0.0394658783705056</c:v>
                  </c:pt>
                  <c:pt idx="5">
                    <c:v>0.0516978400580398</c:v>
                  </c:pt>
                  <c:pt idx="6">
                    <c:v>0.0427629122799965</c:v>
                  </c:pt>
                  <c:pt idx="7">
                    <c:v>0.077461101349143</c:v>
                  </c:pt>
                  <c:pt idx="8">
                    <c:v>0.0187794213613377</c:v>
                  </c:pt>
                </c:numCache>
              </c:numRef>
            </c:minus>
          </c:errBars>
          <c:cat>
            <c:numRef>
              <c:f>Sheet1!$A$14:$A$22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</c:numCache>
            </c:numRef>
          </c:cat>
          <c:val>
            <c:numRef>
              <c:f>Sheet1!$G$14:$G$22</c:f>
              <c:numCache>
                <c:formatCode>General</c:formatCode>
                <c:ptCount val="9"/>
                <c:pt idx="0">
                  <c:v>0.0</c:v>
                </c:pt>
                <c:pt idx="1">
                  <c:v>0.0613333333333333</c:v>
                </c:pt>
                <c:pt idx="2">
                  <c:v>0.243333333333333</c:v>
                </c:pt>
                <c:pt idx="3">
                  <c:v>0.305666666666667</c:v>
                </c:pt>
                <c:pt idx="4">
                  <c:v>0.318333333333333</c:v>
                </c:pt>
                <c:pt idx="5">
                  <c:v>0.324</c:v>
                </c:pt>
                <c:pt idx="6">
                  <c:v>0.319</c:v>
                </c:pt>
                <c:pt idx="7">
                  <c:v>0.343666666666667</c:v>
                </c:pt>
                <c:pt idx="8">
                  <c:v>0.35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00427416"/>
        <c:axId val="-1994087400"/>
      </c:lineChart>
      <c:catAx>
        <c:axId val="-2000427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1994087400"/>
        <c:crossesAt val="0.0"/>
        <c:auto val="1"/>
        <c:lblAlgn val="ctr"/>
        <c:lblOffset val="100"/>
        <c:tickLblSkip val="2"/>
        <c:tickMarkSkip val="2"/>
        <c:noMultiLvlLbl val="0"/>
      </c:catAx>
      <c:valAx>
        <c:axId val="-1994087400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000427416"/>
        <c:crosses val="autoZero"/>
        <c:crossBetween val="midCat"/>
        <c:majorUnit val="0.5"/>
      </c:valAx>
      <c:spPr>
        <a:ln w="6350" cmpd="sng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(-)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olid"/>
            </a:ln>
            <a:effectLst/>
          </c:spPr>
          <c:marker>
            <c:symbol val="squar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2:$L$2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4.189935029992178</c:v>
                  </c:pt>
                  <c:pt idx="3">
                    <c:v>4.898979485566355</c:v>
                  </c:pt>
                  <c:pt idx="4">
                    <c:v>1.247219128924647</c:v>
                  </c:pt>
                </c:numCache>
              </c:numRef>
            </c:plus>
            <c:minus>
              <c:numRef>
                <c:f>Sheet1!$H$2:$L$2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4.189935029992178</c:v>
                  </c:pt>
                  <c:pt idx="3">
                    <c:v>4.898979485566355</c:v>
                  </c:pt>
                  <c:pt idx="4">
                    <c:v>1.247219128924647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2:$F$2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12.6666666666667</c:v>
                </c:pt>
                <c:pt idx="3">
                  <c:v>217.0</c:v>
                </c:pt>
                <c:pt idx="4">
                  <c:v>215.666666666666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② 2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plus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3:$L$3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5.099019513592784</c:v>
                  </c:pt>
                  <c:pt idx="4">
                    <c:v>6.182412330330465</c:v>
                  </c:pt>
                </c:numCache>
              </c:numRef>
            </c:plus>
            <c:minus>
              <c:numRef>
                <c:f>Sheet1!$H$3:$L$3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5.099019513592784</c:v>
                  </c:pt>
                  <c:pt idx="4">
                    <c:v>6.182412330330465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3:$F$3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23.33333333333328</c:v>
                </c:pt>
                <c:pt idx="3">
                  <c:v>20.0</c:v>
                </c:pt>
                <c:pt idx="4">
                  <c:v>19.6666666666666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② 1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x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4:$L$4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1.247219128924647</c:v>
                  </c:pt>
                  <c:pt idx="4">
                    <c:v>0.942809041582063</c:v>
                  </c:pt>
                </c:numCache>
              </c:numRef>
            </c:plus>
            <c:minus>
              <c:numRef>
                <c:f>Sheet1!$H$4:$L$4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1.247219128924647</c:v>
                  </c:pt>
                  <c:pt idx="4">
                    <c:v>0.942809041582063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4:$F$4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44.66666666666641</c:v>
                </c:pt>
                <c:pt idx="3">
                  <c:v>54.66666666666641</c:v>
                </c:pt>
                <c:pt idx="4">
                  <c:v>53.6666666666664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② 1/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5:$L$5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6.683312551921141</c:v>
                  </c:pt>
                  <c:pt idx="3">
                    <c:v>4.496912521077347</c:v>
                  </c:pt>
                  <c:pt idx="4">
                    <c:v>23.15647257727787</c:v>
                  </c:pt>
                </c:numCache>
              </c:numRef>
            </c:plus>
            <c:minus>
              <c:numRef>
                <c:f>Sheet1!$H$5:$L$5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6.683312551921141</c:v>
                  </c:pt>
                  <c:pt idx="3">
                    <c:v>4.496912521077347</c:v>
                  </c:pt>
                  <c:pt idx="4">
                    <c:v>23.15647257727787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5:$F$5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62.0</c:v>
                </c:pt>
                <c:pt idx="3">
                  <c:v>96.3333333333331</c:v>
                </c:pt>
                <c:pt idx="4">
                  <c:v>115.3333333333333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A$6</c:f>
              <c:strCache>
                <c:ptCount val="1"/>
                <c:pt idx="0">
                  <c:v>② 1/16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triang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6:$L$6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03957069398096</c:v>
                  </c:pt>
                  <c:pt idx="3">
                    <c:v>12.7627931460511</c:v>
                  </c:pt>
                  <c:pt idx="4">
                    <c:v>17.15290710702481</c:v>
                  </c:pt>
                </c:numCache>
              </c:numRef>
            </c:plus>
            <c:minus>
              <c:numRef>
                <c:f>Sheet1!$H$6:$L$6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03957069398096</c:v>
                  </c:pt>
                  <c:pt idx="3">
                    <c:v>12.7627931460511</c:v>
                  </c:pt>
                  <c:pt idx="4">
                    <c:v>17.15290710702481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6:$F$6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75.3333333333331</c:v>
                </c:pt>
                <c:pt idx="3">
                  <c:v>165.6666666666667</c:v>
                </c:pt>
                <c:pt idx="4">
                  <c:v>159.3333333333333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heet1!$A$7</c:f>
              <c:strCache>
                <c:ptCount val="1"/>
                <c:pt idx="0">
                  <c:v>② 1/6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7:$L$7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118052168020874</c:v>
                  </c:pt>
                  <c:pt idx="3">
                    <c:v>6.342099196813483</c:v>
                  </c:pt>
                  <c:pt idx="4">
                    <c:v>9.201449161228168</c:v>
                  </c:pt>
                </c:numCache>
              </c:numRef>
            </c:plus>
            <c:minus>
              <c:numRef>
                <c:f>Sheet1!$H$7:$L$7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118052168020874</c:v>
                  </c:pt>
                  <c:pt idx="3">
                    <c:v>6.342099196813483</c:v>
                  </c:pt>
                  <c:pt idx="4">
                    <c:v>9.201449161228168</c:v>
                  </c:pt>
                </c:numCache>
              </c:numRef>
            </c:minus>
          </c:errBars>
          <c:cat>
            <c:numRef>
              <c:f>Sheet1!$B$1:$F$1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7:$F$7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95.0</c:v>
                </c:pt>
                <c:pt idx="3">
                  <c:v>204.3333333333333</c:v>
                </c:pt>
                <c:pt idx="4">
                  <c:v>203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0513720"/>
        <c:axId val="-2028919976"/>
      </c:lineChart>
      <c:catAx>
        <c:axId val="-2140513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028919976"/>
        <c:crosses val="autoZero"/>
        <c:auto val="1"/>
        <c:lblAlgn val="ctr"/>
        <c:lblOffset val="100"/>
        <c:noMultiLvlLbl val="0"/>
      </c:catAx>
      <c:valAx>
        <c:axId val="-2028919976"/>
        <c:scaling>
          <c:orientation val="minMax"/>
          <c:max val="25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140513720"/>
        <c:crossesAt val="0.0"/>
        <c:crossBetween val="midCat"/>
      </c:valAx>
      <c:spPr>
        <a:ln w="6350" cmpd="sng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9</c:f>
              <c:strCache>
                <c:ptCount val="1"/>
                <c:pt idx="0">
                  <c:v>(-)</c:v>
                </c:pt>
              </c:strCache>
            </c:strRef>
          </c:tx>
          <c:spPr>
            <a:ln w="6350" cmpd="sng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9:$L$9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4.189935029992178</c:v>
                  </c:pt>
                  <c:pt idx="3">
                    <c:v>4.898979485566355</c:v>
                  </c:pt>
                  <c:pt idx="4">
                    <c:v>1.247219128924647</c:v>
                  </c:pt>
                </c:numCache>
              </c:numRef>
            </c:plus>
            <c:minus>
              <c:numRef>
                <c:f>Sheet1!$H$9:$L$9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4.189935029992178</c:v>
                  </c:pt>
                  <c:pt idx="3">
                    <c:v>4.898979485566355</c:v>
                  </c:pt>
                  <c:pt idx="4">
                    <c:v>1.247219128924647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9:$F$9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12.6666666666667</c:v>
                </c:pt>
                <c:pt idx="3">
                  <c:v>217.0</c:v>
                </c:pt>
                <c:pt idx="4">
                  <c:v>215.666666666666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10</c:f>
              <c:strCache>
                <c:ptCount val="1"/>
                <c:pt idx="0">
                  <c:v>③ 2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plus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0:$L$10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0.471404520791032</c:v>
                  </c:pt>
                  <c:pt idx="4">
                    <c:v>3.091206165165234</c:v>
                  </c:pt>
                </c:numCache>
              </c:numRef>
            </c:plus>
            <c:minus>
              <c:numRef>
                <c:f>Sheet1!$H$10:$L$10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247219128924647</c:v>
                  </c:pt>
                  <c:pt idx="3">
                    <c:v>0.471404520791032</c:v>
                  </c:pt>
                  <c:pt idx="4">
                    <c:v>3.091206165165234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10:$F$10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1.66666666666667</c:v>
                </c:pt>
                <c:pt idx="3">
                  <c:v>5.666666666666667</c:v>
                </c:pt>
                <c:pt idx="4">
                  <c:v>4.66666666666666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$11</c:f>
              <c:strCache>
                <c:ptCount val="1"/>
                <c:pt idx="0">
                  <c:v>③ 1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x"/>
            <c:size val="7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1:$L$11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699673171197595</c:v>
                  </c:pt>
                  <c:pt idx="3">
                    <c:v>2.828427124746188</c:v>
                  </c:pt>
                  <c:pt idx="4">
                    <c:v>9.201449161228168</c:v>
                  </c:pt>
                </c:numCache>
              </c:numRef>
            </c:plus>
            <c:minus>
              <c:numRef>
                <c:f>Sheet1!$H$11:$L$11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.699673171197595</c:v>
                  </c:pt>
                  <c:pt idx="3">
                    <c:v>2.828427124746188</c:v>
                  </c:pt>
                  <c:pt idx="4">
                    <c:v>9.201449161228168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11:$F$11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45.66666666666641</c:v>
                </c:pt>
                <c:pt idx="3">
                  <c:v>54.0</c:v>
                </c:pt>
                <c:pt idx="4">
                  <c:v>39.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12</c:f>
              <c:strCache>
                <c:ptCount val="1"/>
                <c:pt idx="0">
                  <c:v>③1/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2:$L$12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1.4697670227235</c:v>
                  </c:pt>
                  <c:pt idx="3">
                    <c:v>17.20465053408525</c:v>
                  </c:pt>
                  <c:pt idx="4">
                    <c:v>7.58653778449403</c:v>
                  </c:pt>
                </c:numCache>
              </c:numRef>
            </c:plus>
            <c:minus>
              <c:numRef>
                <c:f>Sheet1!$H$12:$L$12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1.4697670227235</c:v>
                  </c:pt>
                  <c:pt idx="3">
                    <c:v>17.20465053408525</c:v>
                  </c:pt>
                  <c:pt idx="4">
                    <c:v>7.58653778449403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12:$F$12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02.6666666666667</c:v>
                </c:pt>
                <c:pt idx="3">
                  <c:v>149.0</c:v>
                </c:pt>
                <c:pt idx="4">
                  <c:v>166.6666666666667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A$13</c:f>
              <c:strCache>
                <c:ptCount val="1"/>
                <c:pt idx="0">
                  <c:v>③ 1/16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3:$L$13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4.16568624058385</c:v>
                  </c:pt>
                  <c:pt idx="3">
                    <c:v>17.6635217326557</c:v>
                  </c:pt>
                  <c:pt idx="4">
                    <c:v>1.247219128924647</c:v>
                  </c:pt>
                </c:numCache>
              </c:numRef>
            </c:plus>
            <c:minus>
              <c:numRef>
                <c:f>Sheet1!$H$13:$L$13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14.16568624058385</c:v>
                  </c:pt>
                  <c:pt idx="3">
                    <c:v>17.6635217326557</c:v>
                  </c:pt>
                  <c:pt idx="4">
                    <c:v>1.247219128924647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13:$F$13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11.0</c:v>
                </c:pt>
                <c:pt idx="3">
                  <c:v>163.0</c:v>
                </c:pt>
                <c:pt idx="4">
                  <c:v>167.3333333333333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heet1!$A$14</c:f>
              <c:strCache>
                <c:ptCount val="1"/>
                <c:pt idx="0">
                  <c:v>③ 1/64MIC</c:v>
                </c:pt>
              </c:strCache>
            </c:strRef>
          </c:tx>
          <c:spPr>
            <a:ln w="6350" cmpd="sng">
              <a:solidFill>
                <a:schemeClr val="tx1"/>
              </a:solidFill>
              <a:prstDash val="sysDot"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4:$L$14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03957069398096</c:v>
                  </c:pt>
                  <c:pt idx="3">
                    <c:v>11.4697670227235</c:v>
                  </c:pt>
                  <c:pt idx="4">
                    <c:v>26.78722747048592</c:v>
                  </c:pt>
                </c:numCache>
              </c:numRef>
            </c:plus>
            <c:minus>
              <c:numRef>
                <c:f>Sheet1!$H$14:$L$14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13.49073756323204</c:v>
                  </c:pt>
                  <c:pt idx="2">
                    <c:v>7.03957069398096</c:v>
                  </c:pt>
                  <c:pt idx="3">
                    <c:v>11.4697670227235</c:v>
                  </c:pt>
                  <c:pt idx="4">
                    <c:v>26.78722747048592</c:v>
                  </c:pt>
                </c:numCache>
              </c:numRef>
            </c:minus>
          </c:errBars>
          <c:cat>
            <c:numRef>
              <c:f>Sheet1!$B$8:$F$8</c:f>
              <c:numCache>
                <c:formatCode>General</c:formatCode>
                <c:ptCount val="5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Sheet1!$B$14:$F$14</c:f>
              <c:numCache>
                <c:formatCode>General</c:formatCode>
                <c:ptCount val="5"/>
                <c:pt idx="0">
                  <c:v>0.0</c:v>
                </c:pt>
                <c:pt idx="1">
                  <c:v>40.0</c:v>
                </c:pt>
                <c:pt idx="2">
                  <c:v>113.6666666666667</c:v>
                </c:pt>
                <c:pt idx="3">
                  <c:v>215.6666666666667</c:v>
                </c:pt>
                <c:pt idx="4">
                  <c:v>217.333333333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16291944"/>
        <c:axId val="-2140879704"/>
      </c:lineChart>
      <c:catAx>
        <c:axId val="-2016291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140879704"/>
        <c:crosses val="autoZero"/>
        <c:auto val="1"/>
        <c:lblAlgn val="ctr"/>
        <c:lblOffset val="100"/>
        <c:noMultiLvlLbl val="0"/>
      </c:catAx>
      <c:valAx>
        <c:axId val="-2140879704"/>
        <c:scaling>
          <c:orientation val="minMax"/>
          <c:max val="25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"/>
                <a:cs typeface="Times"/>
              </a:defRPr>
            </a:pPr>
            <a:endParaRPr lang="ja-JP"/>
          </a:p>
        </c:txPr>
        <c:crossAx val="-2016291944"/>
        <c:crosses val="autoZero"/>
        <c:crossBetween val="midCat"/>
      </c:valAx>
      <c:spPr>
        <a:ln w="6350" cmpd="sng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441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571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70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9413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9972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733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606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7110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423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98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846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86F9A-1BC4-8441-8BEE-5B618C06AF1F}" type="datetimeFigureOut">
              <a:rPr kumimoji="1" lang="ja-JP" altLang="en-US" smtClean="0"/>
              <a:t>2016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28C23-FCCA-F740-8345-CE63854D7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563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/>
          <p:cNvSpPr txBox="1"/>
          <p:nvPr/>
        </p:nvSpPr>
        <p:spPr>
          <a:xfrm>
            <a:off x="181105" y="5511468"/>
            <a:ext cx="4205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ea typeface="メイリオ"/>
                <a:cs typeface="Times"/>
              </a:rPr>
              <a:t>  </a:t>
            </a:r>
            <a:r>
              <a:rPr lang="en-US" altLang="ja-JP" sz="1200" dirty="0" smtClean="0">
                <a:latin typeface="Times"/>
                <a:ea typeface="メイリオ"/>
                <a:cs typeface="Times"/>
              </a:rPr>
              <a:t>S1 Fig</a:t>
            </a:r>
            <a:r>
              <a:rPr lang="ja-JP" altLang="ja-JP" sz="1200" dirty="0" smtClean="0">
                <a:latin typeface="Times"/>
                <a:ea typeface="メイリオ"/>
                <a:cs typeface="Times"/>
              </a:rPr>
              <a:t> </a:t>
            </a:r>
            <a:r>
              <a:rPr kumimoji="1" lang="en-US" altLang="ja-JP" sz="1200" dirty="0" smtClean="0">
                <a:latin typeface="Times"/>
                <a:ea typeface="メイリオ"/>
                <a:cs typeface="Times"/>
              </a:rPr>
              <a:t>Effect of GRA and GRA derivatives on </a:t>
            </a:r>
            <a:r>
              <a:rPr kumimoji="1" lang="en-US" altLang="ja-JP" sz="1200" i="1" dirty="0" smtClean="0">
                <a:latin typeface="Times"/>
                <a:ea typeface="メイリオ"/>
                <a:cs typeface="Times"/>
              </a:rPr>
              <a:t>S. aureus</a:t>
            </a:r>
            <a:r>
              <a:rPr lang="en-US" altLang="ja-JP" sz="1200" i="1" dirty="0">
                <a:latin typeface="Times"/>
                <a:ea typeface="メイリオ"/>
                <a:cs typeface="Times"/>
              </a:rPr>
              <a:t> </a:t>
            </a:r>
            <a:r>
              <a:rPr kumimoji="1" lang="en-US" altLang="ja-JP" sz="1200" dirty="0" smtClean="0">
                <a:latin typeface="Times"/>
                <a:ea typeface="メイリオ"/>
                <a:cs typeface="Times"/>
              </a:rPr>
              <a:t>growth</a:t>
            </a:r>
            <a:endParaRPr kumimoji="1" lang="ja-JP" altLang="en-US" sz="1200" dirty="0">
              <a:latin typeface="Times"/>
              <a:ea typeface="メイリオ"/>
              <a:cs typeface="Times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544497" y="1450974"/>
            <a:ext cx="1808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Optical Density at 660 nm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cxnSp>
        <p:nvCxnSpPr>
          <p:cNvPr id="8" name="直線矢印コネクタ 7"/>
          <p:cNvCxnSpPr/>
          <p:nvPr/>
        </p:nvCxnSpPr>
        <p:spPr>
          <a:xfrm>
            <a:off x="2614327" y="1907984"/>
            <a:ext cx="0" cy="304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>
            <a:off x="5631129" y="1852406"/>
            <a:ext cx="0" cy="304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25"/>
          <p:cNvSpPr>
            <a:spLocks noChangeArrowheads="1"/>
          </p:cNvSpPr>
          <p:nvPr/>
        </p:nvSpPr>
        <p:spPr bwMode="auto">
          <a:xfrm>
            <a:off x="4969896" y="529508"/>
            <a:ext cx="5095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GRA</a:t>
            </a:r>
            <a:endParaRPr lang="en-US" altLang="ja-JP" sz="1200" dirty="0">
              <a:latin typeface="Times"/>
              <a:cs typeface="Times"/>
            </a:endParaRPr>
          </a:p>
        </p:txBody>
      </p:sp>
      <p:sp>
        <p:nvSpPr>
          <p:cNvPr id="13" name="Rectangle 25"/>
          <p:cNvSpPr>
            <a:spLocks noChangeArrowheads="1"/>
          </p:cNvSpPr>
          <p:nvPr/>
        </p:nvSpPr>
        <p:spPr bwMode="auto">
          <a:xfrm>
            <a:off x="1986195" y="529508"/>
            <a:ext cx="6464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GR-SU</a:t>
            </a:r>
            <a:endParaRPr lang="en-US" altLang="ja-JP" sz="1200" dirty="0">
              <a:latin typeface="Times"/>
              <a:cs typeface="Times"/>
            </a:endParaRPr>
          </a:p>
        </p:txBody>
      </p:sp>
      <p:sp>
        <p:nvSpPr>
          <p:cNvPr id="16" name="Rectangle 25"/>
          <p:cNvSpPr>
            <a:spLocks noChangeArrowheads="1"/>
          </p:cNvSpPr>
          <p:nvPr/>
        </p:nvSpPr>
        <p:spPr bwMode="auto">
          <a:xfrm>
            <a:off x="4969896" y="3055663"/>
            <a:ext cx="5095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GRA</a:t>
            </a:r>
            <a:endParaRPr lang="en-US" altLang="ja-JP" sz="1200" dirty="0">
              <a:latin typeface="Times"/>
              <a:cs typeface="Times"/>
            </a:endParaRPr>
          </a:p>
        </p:txBody>
      </p:sp>
      <p:sp>
        <p:nvSpPr>
          <p:cNvPr id="17" name="Rectangle 25"/>
          <p:cNvSpPr>
            <a:spLocks noChangeArrowheads="1"/>
          </p:cNvSpPr>
          <p:nvPr/>
        </p:nvSpPr>
        <p:spPr bwMode="auto">
          <a:xfrm>
            <a:off x="1986195" y="3055663"/>
            <a:ext cx="64640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GR-SU</a:t>
            </a:r>
            <a:endParaRPr lang="en-US" altLang="ja-JP" sz="1200" dirty="0">
              <a:latin typeface="Times"/>
              <a:cs typeface="Times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941604" y="5273734"/>
            <a:ext cx="7219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Time (h)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922929" y="5241655"/>
            <a:ext cx="7219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Time (h)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591434" y="3904494"/>
            <a:ext cx="1714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Number of CFUs (x 10</a:t>
            </a:r>
            <a:r>
              <a:rPr kumimoji="1" lang="en-US" altLang="ja-JP" sz="1200" baseline="30000" dirty="0" smtClean="0">
                <a:latin typeface="Times"/>
                <a:cs typeface="Times"/>
              </a:rPr>
              <a:t>7</a:t>
            </a:r>
            <a:r>
              <a:rPr kumimoji="1" lang="en-US" altLang="ja-JP" sz="1200" dirty="0" smtClean="0">
                <a:latin typeface="Times"/>
                <a:cs typeface="Times"/>
              </a:rPr>
              <a:t>)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306555" y="5726912"/>
            <a:ext cx="863424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Overnight cultures of </a:t>
            </a:r>
            <a:r>
              <a:rPr lang="en-US" altLang="ja-JP" sz="1200" i="1" dirty="0">
                <a:latin typeface="Times"/>
                <a:cs typeface="Times"/>
              </a:rPr>
              <a:t>S. </a:t>
            </a:r>
            <a:r>
              <a:rPr lang="en-US" altLang="ja-JP" sz="1200" i="1" dirty="0" err="1">
                <a:latin typeface="Times"/>
                <a:cs typeface="Times"/>
              </a:rPr>
              <a:t>aureus</a:t>
            </a:r>
            <a:r>
              <a:rPr lang="en-US" altLang="ja-JP" sz="1200" dirty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MS23513 were </a:t>
            </a:r>
            <a:r>
              <a:rPr lang="en-US" altLang="ja-JP" sz="1200" dirty="0">
                <a:latin typeface="Times"/>
                <a:cs typeface="Times"/>
              </a:rPr>
              <a:t>adjusted to OD 1.0. Then, 100 </a:t>
            </a:r>
            <a:r>
              <a:rPr lang="en-US" altLang="ja-JP" sz="1200" dirty="0" err="1">
                <a:latin typeface="Times"/>
                <a:cs typeface="Times"/>
              </a:rPr>
              <a:t>μl</a:t>
            </a:r>
            <a:r>
              <a:rPr lang="en-US" altLang="ja-JP" sz="1200" dirty="0">
                <a:latin typeface="Times"/>
                <a:cs typeface="Times"/>
              </a:rPr>
              <a:t> of bacterial culture was inoculated to 5 ml TSB. Bacterial culture was incubated at 37°C with shaking. When OD at 660 nm reached 0.3, various concentration </a:t>
            </a:r>
            <a:r>
              <a:rPr lang="en-US" altLang="ja-JP" sz="1200" dirty="0" smtClean="0">
                <a:latin typeface="Times"/>
                <a:cs typeface="Times"/>
              </a:rPr>
              <a:t>(■</a:t>
            </a:r>
            <a:r>
              <a:rPr lang="ja-JP" altLang="en-US" sz="1200" dirty="0" smtClean="0">
                <a:latin typeface="Times"/>
                <a:cs typeface="Times"/>
              </a:rPr>
              <a:t>：</a:t>
            </a:r>
            <a:r>
              <a:rPr lang="en-US" altLang="ja-JP" sz="1200" dirty="0" smtClean="0">
                <a:latin typeface="Times"/>
                <a:cs typeface="Times"/>
              </a:rPr>
              <a:t>control ♦︎:1/64MIC ▲:1/16MIC ●</a:t>
            </a:r>
            <a:r>
              <a:rPr lang="ja-JP" altLang="en-US" sz="1200" dirty="0" smtClean="0">
                <a:latin typeface="Times"/>
                <a:cs typeface="Times"/>
              </a:rPr>
              <a:t>：</a:t>
            </a:r>
            <a:r>
              <a:rPr lang="en-US" altLang="ja-JP" sz="1200" dirty="0" smtClean="0">
                <a:latin typeface="Times"/>
                <a:cs typeface="Times"/>
              </a:rPr>
              <a:t>1/4MIC ×:1MIC </a:t>
            </a:r>
            <a:r>
              <a:rPr lang="ja-JP" altLang="en-US" sz="1200" dirty="0" smtClean="0">
                <a:latin typeface="Times"/>
                <a:cs typeface="Times"/>
              </a:rPr>
              <a:t>十</a:t>
            </a:r>
            <a:r>
              <a:rPr lang="en-US" altLang="ja-JP" sz="1200" dirty="0" smtClean="0">
                <a:latin typeface="Times"/>
                <a:cs typeface="Times"/>
              </a:rPr>
              <a:t>:2MIC) of  GR-SU or  GRA </a:t>
            </a:r>
            <a:r>
              <a:rPr lang="en-US" altLang="ja-JP" sz="1200" dirty="0">
                <a:latin typeface="Times"/>
                <a:cs typeface="Times"/>
              </a:rPr>
              <a:t>was added to the medium.</a:t>
            </a:r>
            <a:r>
              <a:rPr lang="ja-JP" altLang="ja-JP" sz="1200" dirty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Growth and colony count was </a:t>
            </a:r>
            <a:r>
              <a:rPr lang="en-US" altLang="ja-JP" sz="1200" dirty="0">
                <a:latin typeface="Times"/>
                <a:cs typeface="Times"/>
              </a:rPr>
              <a:t>monitored during growth. Three independent experiments were performed, and the mean ± SD was calculated. Data were analyzed for statistically significant differences from untreated control </a:t>
            </a:r>
            <a:r>
              <a:rPr lang="en-US" altLang="ja-JP" sz="1200" dirty="0" smtClean="0">
                <a:latin typeface="Times"/>
                <a:cs typeface="Times"/>
              </a:rPr>
              <a:t>in each time by </a:t>
            </a:r>
            <a:r>
              <a:rPr lang="en-US" altLang="ja-JP" sz="1200" dirty="0">
                <a:latin typeface="Times"/>
                <a:cs typeface="Times"/>
              </a:rPr>
              <a:t>a two-way ANOVA followed by </a:t>
            </a:r>
            <a:r>
              <a:rPr lang="en-US" altLang="ja-JP" sz="1200" dirty="0" err="1">
                <a:latin typeface="Times"/>
                <a:cs typeface="Times"/>
              </a:rPr>
              <a:t>Dunnett’s</a:t>
            </a:r>
            <a:r>
              <a:rPr lang="en-US" altLang="ja-JP" sz="1200" dirty="0">
                <a:latin typeface="Times"/>
                <a:cs typeface="Times"/>
              </a:rPr>
              <a:t> post hoc tests.*P&lt;0.05</a:t>
            </a:r>
            <a:endParaRPr lang="ja-JP" altLang="ja-JP" sz="1200" dirty="0">
              <a:latin typeface="Times"/>
              <a:cs typeface="Times"/>
            </a:endParaRPr>
          </a:p>
          <a:p>
            <a:endParaRPr lang="ja-JP" altLang="ja-JP" sz="1200" dirty="0">
              <a:latin typeface="Times"/>
              <a:cs typeface="Times"/>
            </a:endParaRPr>
          </a:p>
        </p:txBody>
      </p:sp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6455376"/>
              </p:ext>
            </p:extLst>
          </p:nvPr>
        </p:nvGraphicFramePr>
        <p:xfrm>
          <a:off x="1590098" y="405013"/>
          <a:ext cx="3009172" cy="25034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9846283"/>
              </p:ext>
            </p:extLst>
          </p:nvPr>
        </p:nvGraphicFramePr>
        <p:xfrm>
          <a:off x="4596548" y="316363"/>
          <a:ext cx="3152642" cy="25921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グラフ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0979244"/>
              </p:ext>
            </p:extLst>
          </p:nvPr>
        </p:nvGraphicFramePr>
        <p:xfrm>
          <a:off x="1587376" y="2835735"/>
          <a:ext cx="3116640" cy="2469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グラフ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036782"/>
              </p:ext>
            </p:extLst>
          </p:nvPr>
        </p:nvGraphicFramePr>
        <p:xfrm>
          <a:off x="4513751" y="2835735"/>
          <a:ext cx="3235439" cy="2469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846651" y="4253938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886388" y="189973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864688" y="215316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870612" y="221429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163474" y="174545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179250" y="209946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189543" y="217682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464224" y="142894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490293" y="156744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490293" y="207092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498181" y="215316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788638" y="121619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788638" y="144586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796526" y="203984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801337" y="213890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094199" y="97074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088107" y="137573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102087" y="201617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109975" y="213412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402837" y="80650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387061" y="133891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405243" y="197673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413131" y="208670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907153" y="212614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922929" y="2170453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200015" y="1721720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6215791" y="208670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6223679" y="215467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524429" y="1383620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6545824" y="156744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6542611" y="198764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6563869" y="214641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6859137" y="118349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6880532" y="130135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6848979" y="194981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6864755" y="212312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7173393" y="94500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7167775" y="122710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7197057" y="193242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7191575" y="211523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7497807" y="84013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7508101" y="121619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7492325" y="189345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7507965" y="210734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210802" y="410312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3218690" y="425695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228542" y="435530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226578" y="449380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195026" y="467174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843854" y="352726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835966" y="407504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851742" y="439545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822595" y="467962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421019" y="3590377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4442909" y="393654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450165" y="4402630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442277" y="467962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6200015" y="4476882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6176351" y="4749013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6851249" y="358248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6854462" y="3673656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6840955" y="441051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6819697" y="478771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489919" y="3507093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7515988" y="3582489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486843" y="449494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7494594" y="4810240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aseline="30000" dirty="0"/>
              <a:t>*</a:t>
            </a:r>
            <a:endParaRPr kumimoji="1" lang="ja-JP" alt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6357379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47</Words>
  <Application>Microsoft Macintosh PowerPoint</Application>
  <PresentationFormat>画面に合わせる 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山 健太郎</dc:creator>
  <cp:lastModifiedBy>大山 健太郎</cp:lastModifiedBy>
  <cp:revision>7</cp:revision>
  <dcterms:created xsi:type="dcterms:W3CDTF">2016-06-03T08:58:57Z</dcterms:created>
  <dcterms:modified xsi:type="dcterms:W3CDTF">2016-10-21T11:41:54Z</dcterms:modified>
</cp:coreProperties>
</file>